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90" autoAdjust="0"/>
    <p:restoredTop sz="94660"/>
  </p:normalViewPr>
  <p:slideViewPr>
    <p:cSldViewPr snapToGrid="0">
      <p:cViewPr varScale="1">
        <p:scale>
          <a:sx n="69" d="100"/>
          <a:sy n="69" d="100"/>
        </p:scale>
        <p:origin x="271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7276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238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6995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1352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4855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727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923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7672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1821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2008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7778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ACE57B-9D20-4162-82D2-FD89F7721682}" type="datetimeFigureOut">
              <a:rPr lang="fr-FR" smtClean="0"/>
              <a:t>07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8065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ectangle 38"/>
          <p:cNvSpPr/>
          <p:nvPr/>
        </p:nvSpPr>
        <p:spPr>
          <a:xfrm>
            <a:off x="530078" y="1682786"/>
            <a:ext cx="180530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fr-FR" sz="10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mpty</a:t>
            </a:r>
            <a:r>
              <a:rPr lang="fr-FR" sz="1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pGBKT7 / pGAD-CP</a:t>
            </a:r>
            <a:r>
              <a:rPr lang="fr-FR" sz="1000" baseline="-25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a</a:t>
            </a:r>
            <a:r>
              <a:rPr lang="fr-FR" sz="1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fr-FR" sz="10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615779" y="1274735"/>
            <a:ext cx="168347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BKT7-CP</a:t>
            </a:r>
            <a:r>
              <a:rPr lang="fr-FR" sz="1000" baseline="-25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a </a:t>
            </a:r>
            <a:r>
              <a:rPr lang="fr-FR" sz="1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/ pGAD-CP</a:t>
            </a:r>
            <a:r>
              <a:rPr lang="fr-FR" sz="1000" baseline="-25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a</a:t>
            </a:r>
            <a:endParaRPr lang="fr-FR" sz="1000" baseline="-250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2237490" y="997771"/>
            <a:ext cx="698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 pitchFamily="18" charset="0"/>
                <a:cs typeface="Times New Roman" pitchFamily="18" charset="0"/>
              </a:rPr>
              <a:t>[-LW]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3155013" y="997771"/>
            <a:ext cx="9138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smtClean="0">
                <a:latin typeface="Times New Roman" pitchFamily="18" charset="0"/>
                <a:cs typeface="Times New Roman" pitchFamily="18" charset="0"/>
              </a:rPr>
              <a:t>[-LWHA]</a:t>
            </a:r>
          </a:p>
        </p:txBody>
      </p:sp>
      <p:sp>
        <p:nvSpPr>
          <p:cNvPr id="47" name="Rectangle 46"/>
          <p:cNvSpPr/>
          <p:nvPr/>
        </p:nvSpPr>
        <p:spPr>
          <a:xfrm>
            <a:off x="530078" y="2048906"/>
            <a:ext cx="175080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BKT7-CP</a:t>
            </a:r>
            <a:r>
              <a:rPr lang="fr-FR" sz="1000" baseline="-25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a </a:t>
            </a:r>
            <a:r>
              <a:rPr lang="fr-FR" sz="1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/</a:t>
            </a:r>
            <a:r>
              <a:rPr lang="fr-FR" sz="1000" baseline="-25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mpty</a:t>
            </a:r>
            <a:r>
              <a:rPr lang="fr-FR" sz="1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0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AD</a:t>
            </a:r>
            <a:endParaRPr lang="fr-FR" sz="1000" baseline="-250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56698" y="2729032"/>
            <a:ext cx="6297442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4: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sociation of CABYV-CP in yeast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east strain</a:t>
            </a:r>
            <a:r>
              <a:rPr lang="en-US" sz="11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2HGold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 co-transformed with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BKT7-CP</a:t>
            </a:r>
            <a:r>
              <a:rPr lang="en-US" sz="1100" baseline="-250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AD-CP</a:t>
            </a:r>
            <a:r>
              <a:rPr lang="en-US" sz="1100" baseline="-250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In parallel, yeast cells were co-transformed with one of the former recombinant plasmid and one of the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mpty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asmids (empty </a:t>
            </a:r>
            <a:r>
              <a:rPr lang="en-US" sz="1100" dirty="0" err="1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AD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 empty pGBKT7). Three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onies were allowed to grow at 28°C for 5 days on a medium lacking leucine and tryptophan [-LW] before being transferred onto a selective medium deprived of leucine, tryptophan, histidine and adenine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-LWHA</a:t>
            </a:r>
            <a:r>
              <a:rPr lang="en-GB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]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8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4496" r="62988" b="68940"/>
          <a:stretch/>
        </p:blipFill>
        <p:spPr bwMode="auto">
          <a:xfrm>
            <a:off x="2256095" y="1244071"/>
            <a:ext cx="692150" cy="316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9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62790" t="2318" r="4952" b="70729"/>
          <a:stretch/>
        </p:blipFill>
        <p:spPr bwMode="auto">
          <a:xfrm>
            <a:off x="2256096" y="1646669"/>
            <a:ext cx="686676" cy="3061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0" name="Picture 5"/>
          <p:cNvPicPr>
            <a:picLocks noChangeAspect="1" noChangeArrowheads="1"/>
          </p:cNvPicPr>
          <p:nvPr/>
        </p:nvPicPr>
        <p:blipFill rotWithShape="1">
          <a:blip r:embed="rId3" cstate="print"/>
          <a:srcRect l="5120" r="59914" b="70494"/>
          <a:stretch/>
        </p:blipFill>
        <p:spPr bwMode="auto">
          <a:xfrm>
            <a:off x="3247571" y="1250183"/>
            <a:ext cx="702129" cy="3038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" name="Picture 5"/>
          <p:cNvPicPr>
            <a:picLocks noChangeAspect="1" noChangeArrowheads="1"/>
          </p:cNvPicPr>
          <p:nvPr/>
        </p:nvPicPr>
        <p:blipFill rotWithShape="1">
          <a:blip r:embed="rId3" cstate="print"/>
          <a:srcRect l="65447" t="4072" b="67074"/>
          <a:stretch/>
        </p:blipFill>
        <p:spPr bwMode="auto">
          <a:xfrm>
            <a:off x="3248552" y="1650276"/>
            <a:ext cx="693829" cy="3050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2" name="Picture 5"/>
          <p:cNvPicPr>
            <a:picLocks noChangeAspect="1" noChangeArrowheads="1"/>
          </p:cNvPicPr>
          <p:nvPr/>
        </p:nvPicPr>
        <p:blipFill rotWithShape="1">
          <a:blip r:embed="rId3" cstate="print"/>
          <a:srcRect l="63839" t="35008" r="3146" b="37618"/>
          <a:stretch/>
        </p:blipFill>
        <p:spPr bwMode="auto">
          <a:xfrm>
            <a:off x="3251550" y="2046483"/>
            <a:ext cx="691012" cy="3086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3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63938" t="32945" r="3487" b="37856"/>
          <a:stretch/>
        </p:blipFill>
        <p:spPr bwMode="auto">
          <a:xfrm>
            <a:off x="2256095" y="2047875"/>
            <a:ext cx="693421" cy="3068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8322591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7</TotalTime>
  <Words>104</Words>
  <Application>Microsoft Office PowerPoint</Application>
  <PresentationFormat>Format A4 (210 x 297 mm)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ebrault</dc:creator>
  <cp:lastModifiedBy>vebrault</cp:lastModifiedBy>
  <cp:revision>38</cp:revision>
  <cp:lastPrinted>2017-07-31T06:53:54Z</cp:lastPrinted>
  <dcterms:created xsi:type="dcterms:W3CDTF">2017-07-28T14:55:05Z</dcterms:created>
  <dcterms:modified xsi:type="dcterms:W3CDTF">2018-02-07T07:22:01Z</dcterms:modified>
</cp:coreProperties>
</file>